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36"/>
    <p:restoredTop sz="95748"/>
  </p:normalViewPr>
  <p:slideViewPr>
    <p:cSldViewPr snapToGrid="0" snapToObjects="1">
      <p:cViewPr varScale="1">
        <p:scale>
          <a:sx n="75" d="100"/>
          <a:sy n="75" d="100"/>
        </p:scale>
        <p:origin x="6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3701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5130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12362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0652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3303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4719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6118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5520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54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221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69883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607A7-567B-544D-AAD8-B78A3D991E38}" type="datetimeFigureOut">
              <a:rPr kumimoji="1" lang="zh-CN" altLang="en-US" smtClean="0"/>
              <a:t>2021/12/1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5E4E1-08F5-3542-9CAA-12D6A67E038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797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D136F14D-1863-DE40-9FDA-77B5618F6F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7378224"/>
              </p:ext>
            </p:extLst>
          </p:nvPr>
        </p:nvGraphicFramePr>
        <p:xfrm>
          <a:off x="4184082" y="1959429"/>
          <a:ext cx="10700317" cy="660618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735887">
                  <a:extLst>
                    <a:ext uri="{9D8B030D-6E8A-4147-A177-3AD203B41FA5}">
                      <a16:colId xmlns:a16="http://schemas.microsoft.com/office/drawing/2014/main" val="675362837"/>
                    </a:ext>
                  </a:extLst>
                </a:gridCol>
                <a:gridCol w="4404488">
                  <a:extLst>
                    <a:ext uri="{9D8B030D-6E8A-4147-A177-3AD203B41FA5}">
                      <a16:colId xmlns:a16="http://schemas.microsoft.com/office/drawing/2014/main" val="2200490368"/>
                    </a:ext>
                  </a:extLst>
                </a:gridCol>
                <a:gridCol w="4559942">
                  <a:extLst>
                    <a:ext uri="{9D8B030D-6E8A-4147-A177-3AD203B41FA5}">
                      <a16:colId xmlns:a16="http://schemas.microsoft.com/office/drawing/2014/main" val="1084524915"/>
                    </a:ext>
                  </a:extLst>
                </a:gridCol>
              </a:tblGrid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543511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C02569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GTAGAGGAACCAGGT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CGCAGACCAGATAAAGA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74837216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CAATGAGGAGACTTGC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TCTGGAGGTACTCTAGGT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04174690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N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ACCAGACTGTCAGATAC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TCACACCAGGAAACT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26977260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2A1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AGACAGAGGAGAAGCT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AGGACCCTGGATTC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13154660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13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GGCCAAATTATGGAGGA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CAAGTTGTAGCCTTTGGA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08801090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MTS4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ATGTGGATCCTGAGGAG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AGACAGTGCCCATAG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18347012"/>
                  </a:ext>
                </a:extLst>
              </a:tr>
              <a:tr h="66809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MTS5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TACTCGGGAGGATTTATGTG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GGAGAACATATGGTCC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96534021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6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GGTCCCTCAGACATC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AGGACCTTCGGTGA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65206715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1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TTGTACCCTTGTGCCT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AGAAATCTGTCATGCTGG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93598796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3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AGATAGCGATGGTCTGG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CATCCAAATACTCCACA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0085544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AGGCTGGGGCTCATTTG 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GGCCATCCACAGTCTTC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14114927"/>
                  </a:ext>
                </a:extLst>
              </a:tr>
              <a:tr h="49484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CTIN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TGGAACGGTGAAGGTG </a:t>
                      </a: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8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altLang="zh-CN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-</a:t>
                      </a: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GAAGTGGGGTGGCTTTT</a:t>
                      </a:r>
                      <a:r>
                        <a:rPr lang="en-US" altLang="zh-CN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’</a:t>
                      </a: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9674151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62DBD155-2850-764B-8D1D-4F3789013608}"/>
              </a:ext>
            </a:extLst>
          </p:cNvPr>
          <p:cNvSpPr/>
          <p:nvPr/>
        </p:nvSpPr>
        <p:spPr>
          <a:xfrm>
            <a:off x="4184083" y="1502957"/>
            <a:ext cx="6093773" cy="4630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zh-CN" dirty="0"/>
              <a:t>Supplementary 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ble S1. Information of primers. </a:t>
            </a:r>
            <a:endParaRPr lang="zh-CN" altLang="zh-CN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9479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8</TotalTime>
  <Words>124</Words>
  <Application>Microsoft Macintosh PowerPoint</Application>
  <PresentationFormat>自定义</PresentationFormat>
  <Paragraphs>4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yzs</dc:creator>
  <cp:lastModifiedBy>tyzs</cp:lastModifiedBy>
  <cp:revision>18</cp:revision>
  <dcterms:created xsi:type="dcterms:W3CDTF">2021-10-08T02:21:38Z</dcterms:created>
  <dcterms:modified xsi:type="dcterms:W3CDTF">2021-12-17T01:57:22Z</dcterms:modified>
</cp:coreProperties>
</file>